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8" r:id="rId2"/>
    <p:sldId id="261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979" autoAdjust="0"/>
    <p:restoredTop sz="93658" autoAdjust="0"/>
  </p:normalViewPr>
  <p:slideViewPr>
    <p:cSldViewPr snapToGrid="0" showGuides="1">
      <p:cViewPr varScale="1">
        <p:scale>
          <a:sx n="87" d="100"/>
          <a:sy n="87" d="100"/>
        </p:scale>
        <p:origin x="5228" y="52"/>
      </p:cViewPr>
      <p:guideLst>
        <p:guide orient="horz" pos="3840"/>
        <p:guide pos="2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43E3DD-4A77-4D65-9A36-60ADD096E992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1443AB-683C-47ED-90DD-869E16756D6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32945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smtClean="0"/>
              <a:t>WT </a:t>
            </a:r>
            <a:r>
              <a:rPr lang="de-DE" dirty="0" err="1" smtClean="0"/>
              <a:t>virus</a:t>
            </a:r>
            <a:r>
              <a:rPr lang="de-DE" dirty="0" smtClean="0"/>
              <a:t> (OV Patientenisolat)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A1443AB-683C-47ED-90DD-869E16756D68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24778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smtClean="0"/>
              <a:t>WT </a:t>
            </a:r>
            <a:r>
              <a:rPr lang="de-DE" dirty="0" err="1" smtClean="0"/>
              <a:t>virus</a:t>
            </a:r>
            <a:r>
              <a:rPr lang="de-DE" dirty="0" smtClean="0"/>
              <a:t> (OV Patientenisolat)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A1443AB-683C-47ED-90DD-869E16756D68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92805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1841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5620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7128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2558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22686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2451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5331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9654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1453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171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8525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47AEF-2FD5-49E4-879D-CD7B72F86BB3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1D54AF-5E0A-4CB2-8189-71CA9269D3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2040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272" y="817575"/>
            <a:ext cx="3377362" cy="339598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feld 1"/>
          <p:cNvSpPr txBox="1"/>
          <p:nvPr/>
        </p:nvSpPr>
        <p:spPr>
          <a:xfrm>
            <a:off x="341751" y="385437"/>
            <a:ext cx="2529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1a</a:t>
            </a:r>
            <a:endParaRPr lang="de-DE" dirty="0"/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097" y="4939182"/>
            <a:ext cx="3692765" cy="2902712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>
            <a:off x="330530" y="4444238"/>
            <a:ext cx="2540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1b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439561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175395" y="5800386"/>
            <a:ext cx="6507210" cy="354112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27" name="Grafik 26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395" y="1066320"/>
            <a:ext cx="6507210" cy="4734066"/>
          </a:xfrm>
          <a:prstGeom prst="rect">
            <a:avLst/>
          </a:prstGeom>
        </p:spPr>
      </p:pic>
      <p:sp>
        <p:nvSpPr>
          <p:cNvPr id="28" name="Textfeld 27"/>
          <p:cNvSpPr txBox="1"/>
          <p:nvPr/>
        </p:nvSpPr>
        <p:spPr>
          <a:xfrm>
            <a:off x="1172370" y="696988"/>
            <a:ext cx="1531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SARS-CoV-2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3971974" y="696988"/>
            <a:ext cx="24032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SARS-CoV-2/1% P80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5131" y="5911423"/>
            <a:ext cx="3057278" cy="3057278"/>
          </a:xfrm>
          <a:prstGeom prst="rect">
            <a:avLst/>
          </a:prstGeom>
        </p:spPr>
      </p:pic>
      <p:pic>
        <p:nvPicPr>
          <p:cNvPr id="32" name="Grafik 31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076" y="5921329"/>
            <a:ext cx="3037465" cy="3037465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323076" y="82519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860831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7</Words>
  <Application>Microsoft Office PowerPoint</Application>
  <PresentationFormat>Breitbild</PresentationFormat>
  <Paragraphs>9</Paragraphs>
  <Slides>2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lflingseder Doris</dc:creator>
  <cp:lastModifiedBy>Wilflingseder Doris</cp:lastModifiedBy>
  <cp:revision>36</cp:revision>
  <dcterms:created xsi:type="dcterms:W3CDTF">2023-03-29T11:23:47Z</dcterms:created>
  <dcterms:modified xsi:type="dcterms:W3CDTF">2023-04-24T10:37:16Z</dcterms:modified>
</cp:coreProperties>
</file>